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3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25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73757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2003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2752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7772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3957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84528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60464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1189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4232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2288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7394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9D14E-B17D-4DE0-9072-E33073FAF38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5EBBD-6A7C-4112-AC89-33037C2238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1548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C9BFF71-3FA5-42A7-A813-8FD922E86B25}"/>
              </a:ext>
            </a:extLst>
          </p:cNvPr>
          <p:cNvPicPr/>
          <p:nvPr/>
        </p:nvPicPr>
        <p:blipFill rotWithShape="1">
          <a:blip r:embed="rId2"/>
          <a:srcRect l="35416" t="25085" r="18269" b="14197"/>
          <a:stretch/>
        </p:blipFill>
        <p:spPr bwMode="auto">
          <a:xfrm>
            <a:off x="2633317" y="1472727"/>
            <a:ext cx="4639367" cy="323367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7363D60-2737-4491-9D27-CDB68DF88B89}"/>
              </a:ext>
            </a:extLst>
          </p:cNvPr>
          <p:cNvSpPr txBox="1"/>
          <p:nvPr/>
        </p:nvSpPr>
        <p:spPr>
          <a:xfrm>
            <a:off x="852439" y="5232706"/>
            <a:ext cx="8493090" cy="7944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650"/>
              </a:spcAft>
              <a:tabLst>
                <a:tab pos="1226899" algn="l"/>
              </a:tabLs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. 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T-PCR of miRNAs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(A,B)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pected band was obtained in RT-PCR with each of the four miRNAs, namely, miR408-3P, miR395a, miR171i-3p and miR1861d. 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Low range ladder (</a:t>
            </a:r>
            <a:r>
              <a:rPr lang="en-US" sz="1400" dirty="0">
                <a:ea typeface="Times New Roman" panose="02020603050405020304" pitchFamily="18" charset="0"/>
              </a:rPr>
              <a:t>25-700 bp) (Gene ruler, Thermo scientific) was used as reference marker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long with 5.8s (positive control) and water control.</a:t>
            </a:r>
            <a:endParaRPr lang="en-IN" sz="1400" dirty="0"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3070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IRBAD GURIA</dc:creator>
  <cp:lastModifiedBy>Nagesh S</cp:lastModifiedBy>
  <cp:revision>8</cp:revision>
  <dcterms:created xsi:type="dcterms:W3CDTF">2022-02-04T02:14:00Z</dcterms:created>
  <dcterms:modified xsi:type="dcterms:W3CDTF">2022-02-04T09:31:32Z</dcterms:modified>
</cp:coreProperties>
</file>